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GLV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1"/>
                <c:pt idx="0">
                  <c:v>1.24419</c:v>
                </c:pt>
                <c:pt idx="1">
                  <c:v>1.32524</c:v>
                </c:pt>
                <c:pt idx="2">
                  <c:v>1.41644</c:v>
                </c:pt>
                <c:pt idx="3">
                  <c:v>1.52079</c:v>
                </c:pt>
                <c:pt idx="4">
                  <c:v>1.63649</c:v>
                </c:pt>
                <c:pt idx="5">
                  <c:v>1.75881</c:v>
                </c:pt>
                <c:pt idx="6">
                  <c:v>1.88975</c:v>
                </c:pt>
                <c:pt idx="7">
                  <c:v>2.02648</c:v>
                </c:pt>
                <c:pt idx="8">
                  <c:v>2.17295</c:v>
                </c:pt>
                <c:pt idx="9">
                  <c:v>2.32337</c:v>
                </c:pt>
                <c:pt idx="10">
                  <c:v>2.47776</c:v>
                </c:pt>
                <c:pt idx="11">
                  <c:v>2.64012</c:v>
                </c:pt>
                <c:pt idx="12">
                  <c:v>2.81053</c:v>
                </c:pt>
                <c:pt idx="13">
                  <c:v>2.98406</c:v>
                </c:pt>
                <c:pt idx="14">
                  <c:v>3.15573</c:v>
                </c:pt>
                <c:pt idx="15">
                  <c:v>3.32249</c:v>
                </c:pt>
                <c:pt idx="16">
                  <c:v>3.48327</c:v>
                </c:pt>
                <c:pt idx="17">
                  <c:v>3.62991</c:v>
                </c:pt>
                <c:pt idx="18">
                  <c:v>3.76224</c:v>
                </c:pt>
                <c:pt idx="19">
                  <c:v>3.8791</c:v>
                </c:pt>
                <c:pt idx="20">
                  <c:v>3.98235</c:v>
                </c:pt>
                <c:pt idx="21">
                  <c:v>4.06467</c:v>
                </c:pt>
                <c:pt idx="22">
                  <c:v>4.12584</c:v>
                </c:pt>
                <c:pt idx="23">
                  <c:v>4.16719</c:v>
                </c:pt>
                <c:pt idx="24">
                  <c:v>4.18852</c:v>
                </c:pt>
                <c:pt idx="25">
                  <c:v>4.19273</c:v>
                </c:pt>
                <c:pt idx="26">
                  <c:v>4.18854</c:v>
                </c:pt>
                <c:pt idx="27">
                  <c:v>4.19521</c:v>
                </c:pt>
                <c:pt idx="28">
                  <c:v>4.24805</c:v>
                </c:pt>
                <c:pt idx="29">
                  <c:v>4.37492</c:v>
                </c:pt>
                <c:pt idx="30">
                  <c:v>4.56649</c:v>
                </c:pt>
                <c:pt idx="31">
                  <c:v>4.77833</c:v>
                </c:pt>
                <c:pt idx="32">
                  <c:v>4.95422</c:v>
                </c:pt>
                <c:pt idx="33">
                  <c:v>5.04306</c:v>
                </c:pt>
                <c:pt idx="34">
                  <c:v>5.00436</c:v>
                </c:pt>
                <c:pt idx="35">
                  <c:v>4.81807</c:v>
                </c:pt>
                <c:pt idx="36">
                  <c:v>4.57169</c:v>
                </c:pt>
                <c:pt idx="37">
                  <c:v>4.41287</c:v>
                </c:pt>
                <c:pt idx="38">
                  <c:v>4.38803</c:v>
                </c:pt>
                <c:pt idx="39">
                  <c:v>4.42499</c:v>
                </c:pt>
                <c:pt idx="40">
                  <c:v>4.47248</c:v>
                </c:pt>
                <c:pt idx="41">
                  <c:v>4.53004</c:v>
                </c:pt>
                <c:pt idx="42">
                  <c:v>4.59557</c:v>
                </c:pt>
                <c:pt idx="43">
                  <c:v>4.67356</c:v>
                </c:pt>
                <c:pt idx="44">
                  <c:v>4.76798</c:v>
                </c:pt>
                <c:pt idx="45">
                  <c:v>4.88232</c:v>
                </c:pt>
                <c:pt idx="46">
                  <c:v>5.02178</c:v>
                </c:pt>
                <c:pt idx="47">
                  <c:v>5.18937</c:v>
                </c:pt>
                <c:pt idx="48">
                  <c:v>5.38592</c:v>
                </c:pt>
                <c:pt idx="49">
                  <c:v>5.60999</c:v>
                </c:pt>
                <c:pt idx="50">
                  <c:v>5.85563</c:v>
                </c:pt>
                <c:pt idx="51">
                  <c:v>6.11512</c:v>
                </c:pt>
                <c:pt idx="52">
                  <c:v>6.37043</c:v>
                </c:pt>
                <c:pt idx="53">
                  <c:v>6.60501</c:v>
                </c:pt>
                <c:pt idx="54">
                  <c:v>6.79699</c:v>
                </c:pt>
                <c:pt idx="55">
                  <c:v>6.93107</c:v>
                </c:pt>
                <c:pt idx="56">
                  <c:v>6.99208</c:v>
                </c:pt>
                <c:pt idx="57">
                  <c:v>6.98051</c:v>
                </c:pt>
                <c:pt idx="58">
                  <c:v>6.90117</c:v>
                </c:pt>
                <c:pt idx="59">
                  <c:v>6.76997</c:v>
                </c:pt>
                <c:pt idx="60">
                  <c:v>6.60763</c:v>
                </c:pt>
                <c:pt idx="61">
                  <c:v>6.44013</c:v>
                </c:pt>
                <c:pt idx="62">
                  <c:v>6.28845</c:v>
                </c:pt>
                <c:pt idx="63">
                  <c:v>6.17444</c:v>
                </c:pt>
                <c:pt idx="64">
                  <c:v>6.11225</c:v>
                </c:pt>
                <c:pt idx="65">
                  <c:v>6.11151</c:v>
                </c:pt>
                <c:pt idx="66">
                  <c:v>6.17749</c:v>
                </c:pt>
                <c:pt idx="67">
                  <c:v>6.3096</c:v>
                </c:pt>
                <c:pt idx="68">
                  <c:v>6.498</c:v>
                </c:pt>
                <c:pt idx="69">
                  <c:v>6.72737</c:v>
                </c:pt>
                <c:pt idx="70">
                  <c:v>6.97891</c:v>
                </c:pt>
                <c:pt idx="71">
                  <c:v>7.22821</c:v>
                </c:pt>
                <c:pt idx="72">
                  <c:v>7.44829</c:v>
                </c:pt>
                <c:pt idx="73">
                  <c:v>7.61655</c:v>
                </c:pt>
                <c:pt idx="74">
                  <c:v>7.71513</c:v>
                </c:pt>
                <c:pt idx="75">
                  <c:v>7.73797</c:v>
                </c:pt>
                <c:pt idx="76">
                  <c:v>7.68545</c:v>
                </c:pt>
                <c:pt idx="77">
                  <c:v>7.56641</c:v>
                </c:pt>
                <c:pt idx="78">
                  <c:v>7.39635</c:v>
                </c:pt>
                <c:pt idx="79">
                  <c:v>7.20079</c:v>
                </c:pt>
                <c:pt idx="80">
                  <c:v>7.006</c:v>
                </c:pt>
                <c:pt idx="81">
                  <c:v>6.83856</c:v>
                </c:pt>
                <c:pt idx="82">
                  <c:v>6.72177</c:v>
                </c:pt>
                <c:pt idx="83">
                  <c:v>6.67688</c:v>
                </c:pt>
                <c:pt idx="84">
                  <c:v>6.72607</c:v>
                </c:pt>
                <c:pt idx="85">
                  <c:v>6.88746</c:v>
                </c:pt>
                <c:pt idx="86">
                  <c:v>7.1908</c:v>
                </c:pt>
                <c:pt idx="87">
                  <c:v>7.69599</c:v>
                </c:pt>
                <c:pt idx="88">
                  <c:v>8.41375</c:v>
                </c:pt>
                <c:pt idx="89">
                  <c:v>9.27897</c:v>
                </c:pt>
                <c:pt idx="90">
                  <c:v>10.2156</c:v>
                </c:pt>
                <c:pt idx="91">
                  <c:v>11.211</c:v>
                </c:pt>
                <c:pt idx="92">
                  <c:v>12.2697</c:v>
                </c:pt>
                <c:pt idx="93">
                  <c:v>13.3738</c:v>
                </c:pt>
                <c:pt idx="94">
                  <c:v>14.4831</c:v>
                </c:pt>
                <c:pt idx="95">
                  <c:v>15.5516</c:v>
                </c:pt>
                <c:pt idx="96">
                  <c:v>16.5316</c:v>
                </c:pt>
                <c:pt idx="97">
                  <c:v>17.3468</c:v>
                </c:pt>
                <c:pt idx="98">
                  <c:v>17.8892</c:v>
                </c:pt>
                <c:pt idx="99">
                  <c:v>18.0421</c:v>
                </c:pt>
                <c:pt idx="100">
                  <c:v>17.7323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4140891"/>
        <c:axId val="82646802"/>
      </c:lineChart>
      <c:catAx>
        <c:axId val="4140891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82646802"/>
        <c:crosses val="autoZero"/>
        <c:auto val="1"/>
        <c:lblAlgn val="ctr"/>
        <c:lblOffset val="100"/>
        <c:noMultiLvlLbl val="0"/>
      </c:catAx>
      <c:valAx>
        <c:axId val="82646802"/>
        <c:scaling>
          <c:orientation val="minMax"/>
          <c:max val="30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Specific Heat (Kcal/Mol*K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4140891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GCV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1"/>
                <c:pt idx="0">
                  <c:v>1.9625</c:v>
                </c:pt>
                <c:pt idx="1">
                  <c:v>2.02036</c:v>
                </c:pt>
                <c:pt idx="2">
                  <c:v>2.0786</c:v>
                </c:pt>
                <c:pt idx="3">
                  <c:v>2.15068</c:v>
                </c:pt>
                <c:pt idx="4">
                  <c:v>2.2271</c:v>
                </c:pt>
                <c:pt idx="5">
                  <c:v>2.3108</c:v>
                </c:pt>
                <c:pt idx="6">
                  <c:v>2.40089</c:v>
                </c:pt>
                <c:pt idx="7">
                  <c:v>2.49645</c:v>
                </c:pt>
                <c:pt idx="8">
                  <c:v>2.59558</c:v>
                </c:pt>
                <c:pt idx="9">
                  <c:v>2.7042</c:v>
                </c:pt>
                <c:pt idx="10">
                  <c:v>2.82143</c:v>
                </c:pt>
                <c:pt idx="11">
                  <c:v>2.94635</c:v>
                </c:pt>
                <c:pt idx="12">
                  <c:v>3.08004</c:v>
                </c:pt>
                <c:pt idx="13">
                  <c:v>3.21959</c:v>
                </c:pt>
                <c:pt idx="14">
                  <c:v>3.35703</c:v>
                </c:pt>
                <c:pt idx="15">
                  <c:v>3.49133</c:v>
                </c:pt>
                <c:pt idx="16">
                  <c:v>3.61841</c:v>
                </c:pt>
                <c:pt idx="17">
                  <c:v>3.72605</c:v>
                </c:pt>
                <c:pt idx="18">
                  <c:v>3.812</c:v>
                </c:pt>
                <c:pt idx="19">
                  <c:v>3.88215</c:v>
                </c:pt>
                <c:pt idx="20">
                  <c:v>3.93327</c:v>
                </c:pt>
                <c:pt idx="21">
                  <c:v>3.96054</c:v>
                </c:pt>
                <c:pt idx="22">
                  <c:v>3.96011</c:v>
                </c:pt>
                <c:pt idx="23">
                  <c:v>3.93634</c:v>
                </c:pt>
                <c:pt idx="24">
                  <c:v>3.89108</c:v>
                </c:pt>
                <c:pt idx="25">
                  <c:v>3.83086</c:v>
                </c:pt>
                <c:pt idx="26">
                  <c:v>3.76285</c:v>
                </c:pt>
                <c:pt idx="27">
                  <c:v>3.70791</c:v>
                </c:pt>
                <c:pt idx="28">
                  <c:v>3.70241</c:v>
                </c:pt>
                <c:pt idx="29">
                  <c:v>3.77108</c:v>
                </c:pt>
                <c:pt idx="30">
                  <c:v>3.89828</c:v>
                </c:pt>
                <c:pt idx="31">
                  <c:v>4.03949</c:v>
                </c:pt>
                <c:pt idx="32">
                  <c:v>4.14749</c:v>
                </c:pt>
                <c:pt idx="33">
                  <c:v>4.17817</c:v>
                </c:pt>
                <c:pt idx="34">
                  <c:v>4.09648</c:v>
                </c:pt>
                <c:pt idx="35">
                  <c:v>3.88573</c:v>
                </c:pt>
                <c:pt idx="36">
                  <c:v>3.63148</c:v>
                </c:pt>
                <c:pt idx="37">
                  <c:v>3.46961</c:v>
                </c:pt>
                <c:pt idx="38">
                  <c:v>3.44336</c:v>
                </c:pt>
                <c:pt idx="39">
                  <c:v>3.48164</c:v>
                </c:pt>
                <c:pt idx="40">
                  <c:v>3.53539</c:v>
                </c:pt>
                <c:pt idx="41">
                  <c:v>3.59653</c:v>
                </c:pt>
                <c:pt idx="42">
                  <c:v>3.66898</c:v>
                </c:pt>
                <c:pt idx="43">
                  <c:v>3.75285</c:v>
                </c:pt>
                <c:pt idx="44">
                  <c:v>3.84989</c:v>
                </c:pt>
                <c:pt idx="45">
                  <c:v>3.95746</c:v>
                </c:pt>
                <c:pt idx="46">
                  <c:v>4.0762</c:v>
                </c:pt>
                <c:pt idx="47">
                  <c:v>4.20565</c:v>
                </c:pt>
                <c:pt idx="48">
                  <c:v>4.34592</c:v>
                </c:pt>
                <c:pt idx="49">
                  <c:v>4.49035</c:v>
                </c:pt>
                <c:pt idx="50">
                  <c:v>4.63728</c:v>
                </c:pt>
                <c:pt idx="51">
                  <c:v>4.78164</c:v>
                </c:pt>
                <c:pt idx="52">
                  <c:v>4.9183</c:v>
                </c:pt>
                <c:pt idx="53">
                  <c:v>5.04235</c:v>
                </c:pt>
                <c:pt idx="54">
                  <c:v>5.14652</c:v>
                </c:pt>
                <c:pt idx="55">
                  <c:v>5.22634</c:v>
                </c:pt>
                <c:pt idx="56">
                  <c:v>5.27929</c:v>
                </c:pt>
                <c:pt idx="57">
                  <c:v>5.30569</c:v>
                </c:pt>
                <c:pt idx="58">
                  <c:v>5.30646</c:v>
                </c:pt>
                <c:pt idx="59">
                  <c:v>5.28368</c:v>
                </c:pt>
                <c:pt idx="60">
                  <c:v>5.2441</c:v>
                </c:pt>
                <c:pt idx="61">
                  <c:v>5.194</c:v>
                </c:pt>
                <c:pt idx="62">
                  <c:v>5.14116</c:v>
                </c:pt>
                <c:pt idx="63">
                  <c:v>5.09085</c:v>
                </c:pt>
                <c:pt idx="64">
                  <c:v>5.05072</c:v>
                </c:pt>
                <c:pt idx="65">
                  <c:v>5.0259</c:v>
                </c:pt>
                <c:pt idx="66">
                  <c:v>5.02184</c:v>
                </c:pt>
                <c:pt idx="67">
                  <c:v>5.03872</c:v>
                </c:pt>
                <c:pt idx="68">
                  <c:v>5.07525</c:v>
                </c:pt>
                <c:pt idx="69">
                  <c:v>5.12831</c:v>
                </c:pt>
                <c:pt idx="70">
                  <c:v>5.19746</c:v>
                </c:pt>
                <c:pt idx="71">
                  <c:v>5.28102</c:v>
                </c:pt>
                <c:pt idx="72">
                  <c:v>5.37581</c:v>
                </c:pt>
                <c:pt idx="73">
                  <c:v>5.47831</c:v>
                </c:pt>
                <c:pt idx="74">
                  <c:v>5.58676</c:v>
                </c:pt>
                <c:pt idx="75">
                  <c:v>5.70258</c:v>
                </c:pt>
                <c:pt idx="76">
                  <c:v>5.82323</c:v>
                </c:pt>
                <c:pt idx="77">
                  <c:v>5.94218</c:v>
                </c:pt>
                <c:pt idx="78">
                  <c:v>6.05437</c:v>
                </c:pt>
                <c:pt idx="79">
                  <c:v>6.16081</c:v>
                </c:pt>
                <c:pt idx="80">
                  <c:v>6.26607</c:v>
                </c:pt>
                <c:pt idx="81">
                  <c:v>6.3783</c:v>
                </c:pt>
                <c:pt idx="82">
                  <c:v>6.50779</c:v>
                </c:pt>
                <c:pt idx="83">
                  <c:v>6.66865</c:v>
                </c:pt>
                <c:pt idx="84">
                  <c:v>6.87897</c:v>
                </c:pt>
                <c:pt idx="85">
                  <c:v>7.1575</c:v>
                </c:pt>
                <c:pt idx="86">
                  <c:v>7.53519</c:v>
                </c:pt>
                <c:pt idx="87">
                  <c:v>8.07408</c:v>
                </c:pt>
                <c:pt idx="88">
                  <c:v>8.7851</c:v>
                </c:pt>
                <c:pt idx="89">
                  <c:v>9.60208</c:v>
                </c:pt>
                <c:pt idx="90">
                  <c:v>10.4443</c:v>
                </c:pt>
                <c:pt idx="91">
                  <c:v>11.297</c:v>
                </c:pt>
                <c:pt idx="92">
                  <c:v>12.1666</c:v>
                </c:pt>
                <c:pt idx="93">
                  <c:v>13.0424</c:v>
                </c:pt>
                <c:pt idx="94">
                  <c:v>13.8991</c:v>
                </c:pt>
                <c:pt idx="95">
                  <c:v>14.7278</c:v>
                </c:pt>
                <c:pt idx="96">
                  <c:v>15.545</c:v>
                </c:pt>
                <c:pt idx="97">
                  <c:v>16.3551</c:v>
                </c:pt>
                <c:pt idx="98">
                  <c:v>17.1207</c:v>
                </c:pt>
                <c:pt idx="99">
                  <c:v>17.7549</c:v>
                </c:pt>
                <c:pt idx="100">
                  <c:v>18.136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91224389"/>
        <c:axId val="67979609"/>
      </c:lineChart>
      <c:catAx>
        <c:axId val="91224389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67979609"/>
        <c:crosses val="autoZero"/>
        <c:auto val="1"/>
        <c:lblAlgn val="ctr"/>
        <c:lblOffset val="100"/>
        <c:noMultiLvlLbl val="0"/>
      </c:catAx>
      <c:valAx>
        <c:axId val="67979609"/>
        <c:scaling>
          <c:orientation val="minMax"/>
          <c:max val="30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Specific Heat (Kcal/Mol*K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91224389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PISCINE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1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  <c:pt idx="100">
                  <c:v>101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1"/>
                <c:pt idx="0">
                  <c:v>1.18465</c:v>
                </c:pt>
                <c:pt idx="1">
                  <c:v>1.20906</c:v>
                </c:pt>
                <c:pt idx="2">
                  <c:v>1.23555</c:v>
                </c:pt>
                <c:pt idx="3">
                  <c:v>1.26363</c:v>
                </c:pt>
                <c:pt idx="4">
                  <c:v>1.29431</c:v>
                </c:pt>
                <c:pt idx="5">
                  <c:v>1.32711</c:v>
                </c:pt>
                <c:pt idx="6">
                  <c:v>1.36158</c:v>
                </c:pt>
                <c:pt idx="7">
                  <c:v>1.39626</c:v>
                </c:pt>
                <c:pt idx="8">
                  <c:v>1.42968</c:v>
                </c:pt>
                <c:pt idx="9">
                  <c:v>1.46231</c:v>
                </c:pt>
                <c:pt idx="10">
                  <c:v>1.49416</c:v>
                </c:pt>
                <c:pt idx="11">
                  <c:v>1.52669</c:v>
                </c:pt>
                <c:pt idx="12">
                  <c:v>1.55842</c:v>
                </c:pt>
                <c:pt idx="13">
                  <c:v>1.58884</c:v>
                </c:pt>
                <c:pt idx="14">
                  <c:v>1.61692</c:v>
                </c:pt>
                <c:pt idx="15">
                  <c:v>1.64667</c:v>
                </c:pt>
                <c:pt idx="16">
                  <c:v>1.67709</c:v>
                </c:pt>
                <c:pt idx="17">
                  <c:v>1.70921</c:v>
                </c:pt>
                <c:pt idx="18">
                  <c:v>1.74454</c:v>
                </c:pt>
                <c:pt idx="19">
                  <c:v>1.78569</c:v>
                </c:pt>
                <c:pt idx="20">
                  <c:v>1.83321</c:v>
                </c:pt>
                <c:pt idx="21">
                  <c:v>1.88871</c:v>
                </c:pt>
                <c:pt idx="22">
                  <c:v>1.9538</c:v>
                </c:pt>
                <c:pt idx="23">
                  <c:v>2.03014</c:v>
                </c:pt>
                <c:pt idx="24">
                  <c:v>2.11887</c:v>
                </c:pt>
                <c:pt idx="25">
                  <c:v>2.21959</c:v>
                </c:pt>
                <c:pt idx="26">
                  <c:v>2.33502</c:v>
                </c:pt>
                <c:pt idx="27">
                  <c:v>2.46374</c:v>
                </c:pt>
                <c:pt idx="28">
                  <c:v>2.60744</c:v>
                </c:pt>
                <c:pt idx="29">
                  <c:v>2.76416</c:v>
                </c:pt>
                <c:pt idx="30">
                  <c:v>2.93613</c:v>
                </c:pt>
                <c:pt idx="31">
                  <c:v>3.14471</c:v>
                </c:pt>
                <c:pt idx="32">
                  <c:v>3.39984</c:v>
                </c:pt>
                <c:pt idx="33">
                  <c:v>3.67792</c:v>
                </c:pt>
                <c:pt idx="34">
                  <c:v>3.93793</c:v>
                </c:pt>
                <c:pt idx="35">
                  <c:v>4.16409</c:v>
                </c:pt>
                <c:pt idx="36">
                  <c:v>4.35281</c:v>
                </c:pt>
                <c:pt idx="37">
                  <c:v>4.50373</c:v>
                </c:pt>
                <c:pt idx="38">
                  <c:v>4.6189</c:v>
                </c:pt>
                <c:pt idx="39">
                  <c:v>4.70261</c:v>
                </c:pt>
                <c:pt idx="40">
                  <c:v>4.75836</c:v>
                </c:pt>
                <c:pt idx="41">
                  <c:v>4.79245</c:v>
                </c:pt>
                <c:pt idx="42">
                  <c:v>4.81293</c:v>
                </c:pt>
                <c:pt idx="43">
                  <c:v>4.82848</c:v>
                </c:pt>
                <c:pt idx="44">
                  <c:v>4.84845</c:v>
                </c:pt>
                <c:pt idx="45">
                  <c:v>4.87872</c:v>
                </c:pt>
                <c:pt idx="46">
                  <c:v>4.91826</c:v>
                </c:pt>
                <c:pt idx="47">
                  <c:v>4.96382</c:v>
                </c:pt>
                <c:pt idx="48">
                  <c:v>5.01489</c:v>
                </c:pt>
                <c:pt idx="49">
                  <c:v>5.07292</c:v>
                </c:pt>
                <c:pt idx="50">
                  <c:v>5.13797</c:v>
                </c:pt>
                <c:pt idx="51">
                  <c:v>5.20842</c:v>
                </c:pt>
                <c:pt idx="52">
                  <c:v>5.28091</c:v>
                </c:pt>
                <c:pt idx="53">
                  <c:v>5.35204</c:v>
                </c:pt>
                <c:pt idx="54">
                  <c:v>5.41694</c:v>
                </c:pt>
                <c:pt idx="55">
                  <c:v>5.47241</c:v>
                </c:pt>
                <c:pt idx="56">
                  <c:v>5.51592</c:v>
                </c:pt>
                <c:pt idx="57">
                  <c:v>5.54693</c:v>
                </c:pt>
                <c:pt idx="58">
                  <c:v>5.5669</c:v>
                </c:pt>
                <c:pt idx="59">
                  <c:v>5.58024</c:v>
                </c:pt>
                <c:pt idx="60">
                  <c:v>5.5953</c:v>
                </c:pt>
                <c:pt idx="61">
                  <c:v>5.62302</c:v>
                </c:pt>
                <c:pt idx="62">
                  <c:v>5.67915</c:v>
                </c:pt>
                <c:pt idx="63">
                  <c:v>5.78315</c:v>
                </c:pt>
                <c:pt idx="64">
                  <c:v>5.95895</c:v>
                </c:pt>
                <c:pt idx="65">
                  <c:v>6.23358</c:v>
                </c:pt>
                <c:pt idx="66">
                  <c:v>6.6394</c:v>
                </c:pt>
                <c:pt idx="67">
                  <c:v>7.2044</c:v>
                </c:pt>
                <c:pt idx="68">
                  <c:v>7.94722</c:v>
                </c:pt>
                <c:pt idx="69">
                  <c:v>8.86648</c:v>
                </c:pt>
                <c:pt idx="70">
                  <c:v>9.92434</c:v>
                </c:pt>
                <c:pt idx="71">
                  <c:v>11.0294</c:v>
                </c:pt>
                <c:pt idx="72">
                  <c:v>12.0361</c:v>
                </c:pt>
                <c:pt idx="73">
                  <c:v>12.77</c:v>
                </c:pt>
                <c:pt idx="74">
                  <c:v>13.0848</c:v>
                </c:pt>
                <c:pt idx="75">
                  <c:v>12.9187</c:v>
                </c:pt>
                <c:pt idx="76">
                  <c:v>12.313</c:v>
                </c:pt>
                <c:pt idx="77">
                  <c:v>11.3906</c:v>
                </c:pt>
                <c:pt idx="78">
                  <c:v>10.3132</c:v>
                </c:pt>
                <c:pt idx="79">
                  <c:v>9.23235</c:v>
                </c:pt>
                <c:pt idx="80">
                  <c:v>8.25417</c:v>
                </c:pt>
                <c:pt idx="81">
                  <c:v>7.43314</c:v>
                </c:pt>
                <c:pt idx="82">
                  <c:v>6.78397</c:v>
                </c:pt>
                <c:pt idx="83">
                  <c:v>6.29884</c:v>
                </c:pt>
                <c:pt idx="84">
                  <c:v>5.9656</c:v>
                </c:pt>
                <c:pt idx="85">
                  <c:v>5.76504</c:v>
                </c:pt>
                <c:pt idx="86">
                  <c:v>5.674</c:v>
                </c:pt>
                <c:pt idx="87">
                  <c:v>5.67653</c:v>
                </c:pt>
                <c:pt idx="88">
                  <c:v>5.74958</c:v>
                </c:pt>
                <c:pt idx="89">
                  <c:v>5.85386</c:v>
                </c:pt>
                <c:pt idx="90">
                  <c:v>5.95563</c:v>
                </c:pt>
                <c:pt idx="91">
                  <c:v>6.04965</c:v>
                </c:pt>
                <c:pt idx="92">
                  <c:v>6.13423</c:v>
                </c:pt>
                <c:pt idx="93">
                  <c:v>6.19499</c:v>
                </c:pt>
                <c:pt idx="94">
                  <c:v>6.21153</c:v>
                </c:pt>
                <c:pt idx="95">
                  <c:v>6.17224</c:v>
                </c:pt>
                <c:pt idx="96">
                  <c:v>6.075</c:v>
                </c:pt>
                <c:pt idx="97">
                  <c:v>5.91892</c:v>
                </c:pt>
                <c:pt idx="98">
                  <c:v>5.70271</c:v>
                </c:pt>
                <c:pt idx="99">
                  <c:v>5.42768</c:v>
                </c:pt>
                <c:pt idx="100">
                  <c:v>5.10223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98454826"/>
        <c:axId val="84548881"/>
      </c:lineChart>
      <c:catAx>
        <c:axId val="98454826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84548881"/>
        <c:crosses val="autoZero"/>
        <c:auto val="1"/>
        <c:lblAlgn val="ctr"/>
        <c:lblOffset val="100"/>
        <c:noMultiLvlLbl val="0"/>
      </c:catAx>
      <c:valAx>
        <c:axId val="84548881"/>
        <c:scaling>
          <c:orientation val="minMax"/>
          <c:max val="30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Specific Heat (Kcal/Mol*K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98454826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GLV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0"/>
                <c:pt idx="0">
                  <c:v>8.0779E-006</c:v>
                </c:pt>
                <c:pt idx="1">
                  <c:v>8.543E-006</c:v>
                </c:pt>
                <c:pt idx="2">
                  <c:v>9.033E-006</c:v>
                </c:pt>
                <c:pt idx="3">
                  <c:v>9.5495E-006</c:v>
                </c:pt>
                <c:pt idx="4">
                  <c:v>1.0094E-005</c:v>
                </c:pt>
                <c:pt idx="5">
                  <c:v>1.0668E-005</c:v>
                </c:pt>
                <c:pt idx="6">
                  <c:v>1.1272E-005</c:v>
                </c:pt>
                <c:pt idx="7">
                  <c:v>1.191E-005</c:v>
                </c:pt>
                <c:pt idx="8">
                  <c:v>1.2583E-005</c:v>
                </c:pt>
                <c:pt idx="9">
                  <c:v>1.3293E-005</c:v>
                </c:pt>
                <c:pt idx="10">
                  <c:v>1.4043E-005</c:v>
                </c:pt>
                <c:pt idx="11">
                  <c:v>1.4834E-005</c:v>
                </c:pt>
                <c:pt idx="12">
                  <c:v>1.567E-005</c:v>
                </c:pt>
                <c:pt idx="13">
                  <c:v>1.6553E-005</c:v>
                </c:pt>
                <c:pt idx="14">
                  <c:v>1.7487E-005</c:v>
                </c:pt>
                <c:pt idx="15">
                  <c:v>1.8475E-005</c:v>
                </c:pt>
                <c:pt idx="16">
                  <c:v>1.9521E-005</c:v>
                </c:pt>
                <c:pt idx="17">
                  <c:v>2.0629E-005</c:v>
                </c:pt>
                <c:pt idx="18">
                  <c:v>2.1804E-005</c:v>
                </c:pt>
                <c:pt idx="19">
                  <c:v>2.305E-005</c:v>
                </c:pt>
                <c:pt idx="20">
                  <c:v>2.4373E-005</c:v>
                </c:pt>
                <c:pt idx="21">
                  <c:v>2.578E-005</c:v>
                </c:pt>
                <c:pt idx="22">
                  <c:v>2.7276E-005</c:v>
                </c:pt>
                <c:pt idx="23">
                  <c:v>2.887E-005</c:v>
                </c:pt>
                <c:pt idx="24">
                  <c:v>3.0569E-005</c:v>
                </c:pt>
                <c:pt idx="25">
                  <c:v>3.2383E-005</c:v>
                </c:pt>
                <c:pt idx="26">
                  <c:v>3.4321E-005</c:v>
                </c:pt>
                <c:pt idx="27">
                  <c:v>3.6396E-005</c:v>
                </c:pt>
                <c:pt idx="28">
                  <c:v>3.862E-005</c:v>
                </c:pt>
                <c:pt idx="29">
                  <c:v>4.1007E-005</c:v>
                </c:pt>
                <c:pt idx="30">
                  <c:v>4.3574E-005</c:v>
                </c:pt>
                <c:pt idx="31">
                  <c:v>4.6337E-005</c:v>
                </c:pt>
                <c:pt idx="32">
                  <c:v>4.9317E-005</c:v>
                </c:pt>
                <c:pt idx="33">
                  <c:v>5.2537E-005</c:v>
                </c:pt>
                <c:pt idx="34">
                  <c:v>5.6023E-005</c:v>
                </c:pt>
                <c:pt idx="35">
                  <c:v>5.9802E-005</c:v>
                </c:pt>
                <c:pt idx="36">
                  <c:v>6.3907E-005</c:v>
                </c:pt>
                <c:pt idx="37">
                  <c:v>6.8376E-005</c:v>
                </c:pt>
                <c:pt idx="38">
                  <c:v>7.3249E-005</c:v>
                </c:pt>
                <c:pt idx="39">
                  <c:v>7.8572E-005</c:v>
                </c:pt>
                <c:pt idx="40">
                  <c:v>8.4399E-005</c:v>
                </c:pt>
                <c:pt idx="41">
                  <c:v>9.0789E-005</c:v>
                </c:pt>
                <c:pt idx="42">
                  <c:v>9.781E-005</c:v>
                </c:pt>
                <c:pt idx="43">
                  <c:v>0.00010554</c:v>
                </c:pt>
                <c:pt idx="44">
                  <c:v>0.00011406</c:v>
                </c:pt>
                <c:pt idx="45">
                  <c:v>0.00012346</c:v>
                </c:pt>
                <c:pt idx="46">
                  <c:v>0.00013387</c:v>
                </c:pt>
                <c:pt idx="47">
                  <c:v>0.00014539</c:v>
                </c:pt>
                <c:pt idx="48">
                  <c:v>0.00015817</c:v>
                </c:pt>
                <c:pt idx="49">
                  <c:v>0.00017236</c:v>
                </c:pt>
                <c:pt idx="50">
                  <c:v>0.00018814</c:v>
                </c:pt>
                <c:pt idx="51">
                  <c:v>0.00020568</c:v>
                </c:pt>
                <c:pt idx="52">
                  <c:v>0.00022521</c:v>
                </c:pt>
                <c:pt idx="53">
                  <c:v>0.00024696</c:v>
                </c:pt>
                <c:pt idx="54">
                  <c:v>0.00027118</c:v>
                </c:pt>
                <c:pt idx="55">
                  <c:v>0.00029815</c:v>
                </c:pt>
                <c:pt idx="56">
                  <c:v>0.00032818</c:v>
                </c:pt>
                <c:pt idx="57">
                  <c:v>0.0003616</c:v>
                </c:pt>
                <c:pt idx="58">
                  <c:v>0.00039874</c:v>
                </c:pt>
                <c:pt idx="59">
                  <c:v>0.00043999</c:v>
                </c:pt>
                <c:pt idx="60">
                  <c:v>0.00048573</c:v>
                </c:pt>
                <c:pt idx="61">
                  <c:v>0.00053634</c:v>
                </c:pt>
                <c:pt idx="62">
                  <c:v>0.00059223</c:v>
                </c:pt>
                <c:pt idx="63">
                  <c:v>0.0006538</c:v>
                </c:pt>
                <c:pt idx="64">
                  <c:v>0.00072144</c:v>
                </c:pt>
                <c:pt idx="65">
                  <c:v>0.00079554</c:v>
                </c:pt>
                <c:pt idx="66">
                  <c:v>0.00087649</c:v>
                </c:pt>
                <c:pt idx="67">
                  <c:v>0.00096468</c:v>
                </c:pt>
                <c:pt idx="68">
                  <c:v>0.0010606</c:v>
                </c:pt>
                <c:pt idx="69">
                  <c:v>0.0011648</c:v>
                </c:pt>
                <c:pt idx="70">
                  <c:v>0.0012786</c:v>
                </c:pt>
                <c:pt idx="71">
                  <c:v>0.0014048</c:v>
                </c:pt>
                <c:pt idx="72">
                  <c:v>0.0015557</c:v>
                </c:pt>
                <c:pt idx="73">
                  <c:v>0.0017993</c:v>
                </c:pt>
                <c:pt idx="74">
                  <c:v>0.00259</c:v>
                </c:pt>
                <c:pt idx="75">
                  <c:v>0.0070719</c:v>
                </c:pt>
                <c:pt idx="76">
                  <c:v>0.033728</c:v>
                </c:pt>
                <c:pt idx="77">
                  <c:v>0.11273</c:v>
                </c:pt>
                <c:pt idx="78">
                  <c:v>0.10458</c:v>
                </c:pt>
                <c:pt idx="79">
                  <c:v>0.031219</c:v>
                </c:pt>
                <c:pt idx="80">
                  <c:v>0.010524</c:v>
                </c:pt>
                <c:pt idx="81">
                  <c:v>0.0083969</c:v>
                </c:pt>
                <c:pt idx="82">
                  <c:v>0.011632</c:v>
                </c:pt>
                <c:pt idx="83">
                  <c:v>0.032406</c:v>
                </c:pt>
                <c:pt idx="84">
                  <c:v>0.13391</c:v>
                </c:pt>
                <c:pt idx="85">
                  <c:v>0.20221</c:v>
                </c:pt>
                <c:pt idx="86">
                  <c:v>0.098885</c:v>
                </c:pt>
                <c:pt idx="87">
                  <c:v>0.049697</c:v>
                </c:pt>
                <c:pt idx="88">
                  <c:v>0.028632</c:v>
                </c:pt>
                <c:pt idx="89">
                  <c:v>0.018859</c:v>
                </c:pt>
                <c:pt idx="90">
                  <c:v>0.014363</c:v>
                </c:pt>
                <c:pt idx="91">
                  <c:v>0.011857</c:v>
                </c:pt>
                <c:pt idx="92">
                  <c:v>0.0099586</c:v>
                </c:pt>
                <c:pt idx="93">
                  <c:v>0.0082394</c:v>
                </c:pt>
                <c:pt idx="94">
                  <c:v>0.0066626</c:v>
                </c:pt>
                <c:pt idx="95">
                  <c:v>0.0052913</c:v>
                </c:pt>
                <c:pt idx="96">
                  <c:v>0.0041658</c:v>
                </c:pt>
                <c:pt idx="97">
                  <c:v>0.0032812</c:v>
                </c:pt>
                <c:pt idx="98">
                  <c:v>0.0026037</c:v>
                </c:pt>
                <c:pt idx="99">
                  <c:v>0.0020905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22839584"/>
        <c:axId val="45248140"/>
      </c:lineChart>
      <c:catAx>
        <c:axId val="22839584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45248140"/>
        <c:crosses val="autoZero"/>
        <c:auto val="1"/>
        <c:lblAlgn val="ctr"/>
        <c:lblOffset val="100"/>
        <c:noMultiLvlLbl val="0"/>
      </c:catAx>
      <c:valAx>
        <c:axId val="45248140"/>
        <c:scaling>
          <c:orientation val="minMax"/>
          <c:max val="0.3"/>
          <c:min val="0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dθ/dT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22839584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GCV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0"/>
                <c:pt idx="0">
                  <c:v>9.9942E-006</c:v>
                </c:pt>
                <c:pt idx="1">
                  <c:v>1.0687E-005</c:v>
                </c:pt>
                <c:pt idx="2">
                  <c:v>1.143E-005</c:v>
                </c:pt>
                <c:pt idx="3">
                  <c:v>1.2228E-005</c:v>
                </c:pt>
                <c:pt idx="4">
                  <c:v>1.3086E-005</c:v>
                </c:pt>
                <c:pt idx="5">
                  <c:v>1.4007E-005</c:v>
                </c:pt>
                <c:pt idx="6">
                  <c:v>1.4999E-005</c:v>
                </c:pt>
                <c:pt idx="7">
                  <c:v>1.6067E-005</c:v>
                </c:pt>
                <c:pt idx="8">
                  <c:v>1.7217E-005</c:v>
                </c:pt>
                <c:pt idx="9">
                  <c:v>1.8457E-005</c:v>
                </c:pt>
                <c:pt idx="10">
                  <c:v>1.9795E-005</c:v>
                </c:pt>
                <c:pt idx="11">
                  <c:v>2.124E-005</c:v>
                </c:pt>
                <c:pt idx="12">
                  <c:v>2.28E-005</c:v>
                </c:pt>
                <c:pt idx="13">
                  <c:v>2.4488E-005</c:v>
                </c:pt>
                <c:pt idx="14">
                  <c:v>2.6314E-005</c:v>
                </c:pt>
                <c:pt idx="15">
                  <c:v>2.8291E-005</c:v>
                </c:pt>
                <c:pt idx="16">
                  <c:v>3.0434E-005</c:v>
                </c:pt>
                <c:pt idx="17">
                  <c:v>3.2758E-005</c:v>
                </c:pt>
                <c:pt idx="18">
                  <c:v>3.5281E-005</c:v>
                </c:pt>
                <c:pt idx="19">
                  <c:v>3.8022E-005</c:v>
                </c:pt>
                <c:pt idx="20">
                  <c:v>4.1002E-005</c:v>
                </c:pt>
                <c:pt idx="21">
                  <c:v>4.4245E-005</c:v>
                </c:pt>
                <c:pt idx="22">
                  <c:v>4.7775E-005</c:v>
                </c:pt>
                <c:pt idx="23">
                  <c:v>5.1622E-005</c:v>
                </c:pt>
                <c:pt idx="24">
                  <c:v>5.5817E-005</c:v>
                </c:pt>
                <c:pt idx="25">
                  <c:v>6.0395E-005</c:v>
                </c:pt>
                <c:pt idx="26">
                  <c:v>6.5394E-005</c:v>
                </c:pt>
                <c:pt idx="27">
                  <c:v>7.0855E-005</c:v>
                </c:pt>
                <c:pt idx="28">
                  <c:v>7.6825E-005</c:v>
                </c:pt>
                <c:pt idx="29">
                  <c:v>8.3356E-005</c:v>
                </c:pt>
                <c:pt idx="30">
                  <c:v>9.0502E-005</c:v>
                </c:pt>
                <c:pt idx="31">
                  <c:v>9.8325E-005</c:v>
                </c:pt>
                <c:pt idx="32">
                  <c:v>0.00010689</c:v>
                </c:pt>
                <c:pt idx="33">
                  <c:v>0.00011627</c:v>
                </c:pt>
                <c:pt idx="34">
                  <c:v>0.00012655</c:v>
                </c:pt>
                <c:pt idx="35">
                  <c:v>0.00013781</c:v>
                </c:pt>
                <c:pt idx="36">
                  <c:v>0.00015014</c:v>
                </c:pt>
                <c:pt idx="37">
                  <c:v>0.00016364</c:v>
                </c:pt>
                <c:pt idx="38">
                  <c:v>0.00017842</c:v>
                </c:pt>
                <c:pt idx="39">
                  <c:v>0.00019458</c:v>
                </c:pt>
                <c:pt idx="40">
                  <c:v>0.00021225</c:v>
                </c:pt>
                <c:pt idx="41">
                  <c:v>0.00023155</c:v>
                </c:pt>
                <c:pt idx="42">
                  <c:v>0.0002526</c:v>
                </c:pt>
                <c:pt idx="43">
                  <c:v>0.00027553</c:v>
                </c:pt>
                <c:pt idx="44">
                  <c:v>0.00030048</c:v>
                </c:pt>
                <c:pt idx="45">
                  <c:v>0.00032756</c:v>
                </c:pt>
                <c:pt idx="46">
                  <c:v>0.00035691</c:v>
                </c:pt>
                <c:pt idx="47">
                  <c:v>0.00038864</c:v>
                </c:pt>
                <c:pt idx="48">
                  <c:v>0.00042285</c:v>
                </c:pt>
                <c:pt idx="49">
                  <c:v>0.00045965</c:v>
                </c:pt>
                <c:pt idx="50">
                  <c:v>0.00049911</c:v>
                </c:pt>
                <c:pt idx="51">
                  <c:v>0.00054129</c:v>
                </c:pt>
                <c:pt idx="52">
                  <c:v>0.00058624</c:v>
                </c:pt>
                <c:pt idx="53">
                  <c:v>0.00063398</c:v>
                </c:pt>
                <c:pt idx="54">
                  <c:v>0.00068452</c:v>
                </c:pt>
                <c:pt idx="55">
                  <c:v>0.00073788</c:v>
                </c:pt>
                <c:pt idx="56">
                  <c:v>0.00079405</c:v>
                </c:pt>
                <c:pt idx="57">
                  <c:v>0.00085307</c:v>
                </c:pt>
                <c:pt idx="58">
                  <c:v>0.00091501</c:v>
                </c:pt>
                <c:pt idx="59">
                  <c:v>0.00098001</c:v>
                </c:pt>
                <c:pt idx="60">
                  <c:v>0.0010483</c:v>
                </c:pt>
                <c:pt idx="61">
                  <c:v>0.0011203</c:v>
                </c:pt>
                <c:pt idx="62">
                  <c:v>0.0011966</c:v>
                </c:pt>
                <c:pt idx="63">
                  <c:v>0.0012781</c:v>
                </c:pt>
                <c:pt idx="64">
                  <c:v>0.0013658</c:v>
                </c:pt>
                <c:pt idx="65">
                  <c:v>0.0014614</c:v>
                </c:pt>
                <c:pt idx="66">
                  <c:v>0.0015666</c:v>
                </c:pt>
                <c:pt idx="67">
                  <c:v>0.0016838</c:v>
                </c:pt>
                <c:pt idx="68">
                  <c:v>0.0018158</c:v>
                </c:pt>
                <c:pt idx="69">
                  <c:v>0.0019658</c:v>
                </c:pt>
                <c:pt idx="70">
                  <c:v>0.0021376</c:v>
                </c:pt>
                <c:pt idx="71">
                  <c:v>0.002336</c:v>
                </c:pt>
                <c:pt idx="72">
                  <c:v>0.0025692</c:v>
                </c:pt>
                <c:pt idx="73">
                  <c:v>0.0028624</c:v>
                </c:pt>
                <c:pt idx="74">
                  <c:v>0.0033448</c:v>
                </c:pt>
                <c:pt idx="75">
                  <c:v>0.0048006</c:v>
                </c:pt>
                <c:pt idx="76">
                  <c:v>0.011974</c:v>
                </c:pt>
                <c:pt idx="77">
                  <c:v>0.046177</c:v>
                </c:pt>
                <c:pt idx="78">
                  <c:v>0.11226</c:v>
                </c:pt>
                <c:pt idx="79">
                  <c:v>0.082295</c:v>
                </c:pt>
                <c:pt idx="80">
                  <c:v>0.02569</c:v>
                </c:pt>
                <c:pt idx="81">
                  <c:v>0.010967</c:v>
                </c:pt>
                <c:pt idx="82">
                  <c:v>0.012439</c:v>
                </c:pt>
                <c:pt idx="83">
                  <c:v>0.036988</c:v>
                </c:pt>
                <c:pt idx="84">
                  <c:v>0.15676</c:v>
                </c:pt>
                <c:pt idx="85">
                  <c:v>0.21573</c:v>
                </c:pt>
                <c:pt idx="86">
                  <c:v>0.090687</c:v>
                </c:pt>
                <c:pt idx="87">
                  <c:v>0.037642</c:v>
                </c:pt>
                <c:pt idx="88">
                  <c:v>0.020252</c:v>
                </c:pt>
                <c:pt idx="89">
                  <c:v>0.014052</c:v>
                </c:pt>
                <c:pt idx="90">
                  <c:v>0.011344</c:v>
                </c:pt>
                <c:pt idx="91">
                  <c:v>0.0096063</c:v>
                </c:pt>
                <c:pt idx="92">
                  <c:v>0.0081085</c:v>
                </c:pt>
                <c:pt idx="93">
                  <c:v>0.0067183</c:v>
                </c:pt>
                <c:pt idx="94">
                  <c:v>0.0054695</c:v>
                </c:pt>
                <c:pt idx="95">
                  <c:v>0.0044052</c:v>
                </c:pt>
                <c:pt idx="96">
                  <c:v>0.0035369</c:v>
                </c:pt>
                <c:pt idx="97">
                  <c:v>0.0028485</c:v>
                </c:pt>
                <c:pt idx="98">
                  <c:v>0.0023108</c:v>
                </c:pt>
                <c:pt idx="99">
                  <c:v>0.0018927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23362912"/>
        <c:axId val="96471493"/>
      </c:lineChart>
      <c:catAx>
        <c:axId val="23362912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96471493"/>
        <c:crosses val="autoZero"/>
        <c:auto val="1"/>
        <c:lblAlgn val="ctr"/>
        <c:lblOffset val="100"/>
        <c:noMultiLvlLbl val="0"/>
      </c:catAx>
      <c:valAx>
        <c:axId val="96471493"/>
        <c:scaling>
          <c:orientation val="minMax"/>
          <c:max val="0.3"/>
          <c:min val="0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dθ/dT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23362912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roundedCorners val="0"/>
  <c:chart>
    <c:autoTitleDeleted val="1"/>
    <c:plotArea>
      <c:lineChart>
        <c:grouping val="standard"/>
        <c:varyColors val="0"/>
        <c:ser>
          <c:idx val="0"/>
          <c:order val="0"/>
          <c:tx>
            <c:strRef>
              <c:f>label 0</c:f>
              <c:strCache>
                <c:ptCount val="1"/>
                <c:pt idx="0">
                  <c:v>PISCINE</c:v>
                </c:pt>
              </c:strCache>
            </c:strRef>
          </c:tx>
          <c:spPr>
            <a:solidFill>
              <a:srgbClr val="004586"/>
            </a:solidFill>
            <a:ln w="28800">
              <a:solidFill>
                <a:srgbClr val="004586"/>
              </a:solidFill>
              <a:round/>
            </a:ln>
          </c:spPr>
          <c:marker>
            <c:symbol val="none"/>
          </c:marker>
          <c:dLbls>
            <c:txPr>
              <a:bodyPr wrap="none"/>
              <a:lstStyle/>
              <a:p>
                <a:pPr>
                  <a:defRPr b="0" sz="1000" spc="-1" strike="noStrike">
                    <a:solidFill>
                      <a:srgbClr val="000000"/>
                    </a:solidFill>
                    <a:latin typeface="Arial"/>
                  </a:defRPr>
                </a:pPr>
              </a:p>
            </c:txPr>
            <c:showLegendKey val="0"/>
            <c:showVal val="0"/>
            <c:showCatName val="0"/>
            <c:showSerName val="0"/>
            <c:showPercent val="0"/>
            <c:separator> </c:separator>
            <c:showLeaderLines val="1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categories</c:f>
              <c:strCache>
                <c:ptCount val="100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53</c:v>
                </c:pt>
                <c:pt idx="53">
                  <c:v>54</c:v>
                </c:pt>
                <c:pt idx="54">
                  <c:v>55</c:v>
                </c:pt>
                <c:pt idx="55">
                  <c:v>56</c:v>
                </c:pt>
                <c:pt idx="56">
                  <c:v>57</c:v>
                </c:pt>
                <c:pt idx="57">
                  <c:v>58</c:v>
                </c:pt>
                <c:pt idx="58">
                  <c:v>59</c:v>
                </c:pt>
                <c:pt idx="59">
                  <c:v>60</c:v>
                </c:pt>
                <c:pt idx="60">
                  <c:v>61</c:v>
                </c:pt>
                <c:pt idx="61">
                  <c:v>62</c:v>
                </c:pt>
                <c:pt idx="62">
                  <c:v>63</c:v>
                </c:pt>
                <c:pt idx="63">
                  <c:v>64</c:v>
                </c:pt>
                <c:pt idx="64">
                  <c:v>65</c:v>
                </c:pt>
                <c:pt idx="65">
                  <c:v>66</c:v>
                </c:pt>
                <c:pt idx="66">
                  <c:v>67</c:v>
                </c:pt>
                <c:pt idx="67">
                  <c:v>68</c:v>
                </c:pt>
                <c:pt idx="68">
                  <c:v>69</c:v>
                </c:pt>
                <c:pt idx="69">
                  <c:v>70</c:v>
                </c:pt>
                <c:pt idx="70">
                  <c:v>71</c:v>
                </c:pt>
                <c:pt idx="71">
                  <c:v>72</c:v>
                </c:pt>
                <c:pt idx="72">
                  <c:v>73</c:v>
                </c:pt>
                <c:pt idx="73">
                  <c:v>74</c:v>
                </c:pt>
                <c:pt idx="74">
                  <c:v>75</c:v>
                </c:pt>
                <c:pt idx="75">
                  <c:v>76</c:v>
                </c:pt>
                <c:pt idx="76">
                  <c:v>77</c:v>
                </c:pt>
                <c:pt idx="77">
                  <c:v>78</c:v>
                </c:pt>
                <c:pt idx="78">
                  <c:v>79</c:v>
                </c:pt>
                <c:pt idx="79">
                  <c:v>80</c:v>
                </c:pt>
                <c:pt idx="80">
                  <c:v>81</c:v>
                </c:pt>
                <c:pt idx="81">
                  <c:v>82</c:v>
                </c:pt>
                <c:pt idx="82">
                  <c:v>83</c:v>
                </c:pt>
                <c:pt idx="83">
                  <c:v>84</c:v>
                </c:pt>
                <c:pt idx="84">
                  <c:v>85</c:v>
                </c:pt>
                <c:pt idx="85">
                  <c:v>86</c:v>
                </c:pt>
                <c:pt idx="86">
                  <c:v>87</c:v>
                </c:pt>
                <c:pt idx="87">
                  <c:v>88</c:v>
                </c:pt>
                <c:pt idx="88">
                  <c:v>89</c:v>
                </c:pt>
                <c:pt idx="89">
                  <c:v>90</c:v>
                </c:pt>
                <c:pt idx="90">
                  <c:v>91</c:v>
                </c:pt>
                <c:pt idx="91">
                  <c:v>92</c:v>
                </c:pt>
                <c:pt idx="92">
                  <c:v>93</c:v>
                </c:pt>
                <c:pt idx="93">
                  <c:v>94</c:v>
                </c:pt>
                <c:pt idx="94">
                  <c:v>95</c:v>
                </c:pt>
                <c:pt idx="95">
                  <c:v>96</c:v>
                </c:pt>
                <c:pt idx="96">
                  <c:v>97</c:v>
                </c:pt>
                <c:pt idx="97">
                  <c:v>98</c:v>
                </c:pt>
                <c:pt idx="98">
                  <c:v>99</c:v>
                </c:pt>
                <c:pt idx="99">
                  <c:v>100</c:v>
                </c:pt>
              </c:strCache>
            </c:strRef>
          </c:cat>
          <c:val>
            <c:numRef>
              <c:f>0</c:f>
              <c:numCache>
                <c:formatCode>General</c:formatCode>
                <c:ptCount val="100"/>
                <c:pt idx="0">
                  <c:v>2.2522E-005</c:v>
                </c:pt>
                <c:pt idx="1">
                  <c:v>2.3859E-005</c:v>
                </c:pt>
                <c:pt idx="2">
                  <c:v>2.5273E-005</c:v>
                </c:pt>
                <c:pt idx="3">
                  <c:v>2.6768E-005</c:v>
                </c:pt>
                <c:pt idx="4">
                  <c:v>2.8348E-005</c:v>
                </c:pt>
                <c:pt idx="5">
                  <c:v>3.0018E-005</c:v>
                </c:pt>
                <c:pt idx="6">
                  <c:v>3.1784E-005</c:v>
                </c:pt>
                <c:pt idx="7">
                  <c:v>3.3651E-005</c:v>
                </c:pt>
                <c:pt idx="8">
                  <c:v>3.5623E-005</c:v>
                </c:pt>
                <c:pt idx="9">
                  <c:v>3.7708E-005</c:v>
                </c:pt>
                <c:pt idx="10">
                  <c:v>3.9911E-005</c:v>
                </c:pt>
                <c:pt idx="11">
                  <c:v>4.2238E-005</c:v>
                </c:pt>
                <c:pt idx="12">
                  <c:v>4.4697E-005</c:v>
                </c:pt>
                <c:pt idx="13">
                  <c:v>4.7294E-005</c:v>
                </c:pt>
                <c:pt idx="14">
                  <c:v>5.0035E-005</c:v>
                </c:pt>
                <c:pt idx="15">
                  <c:v>5.293E-005</c:v>
                </c:pt>
                <c:pt idx="16">
                  <c:v>5.5984E-005</c:v>
                </c:pt>
                <c:pt idx="17">
                  <c:v>5.9207E-005</c:v>
                </c:pt>
                <c:pt idx="18">
                  <c:v>6.2605E-005</c:v>
                </c:pt>
                <c:pt idx="19">
                  <c:v>6.6188E-005</c:v>
                </c:pt>
                <c:pt idx="20">
                  <c:v>6.9963E-005</c:v>
                </c:pt>
                <c:pt idx="21">
                  <c:v>7.3938E-005</c:v>
                </c:pt>
                <c:pt idx="22">
                  <c:v>7.8124E-005</c:v>
                </c:pt>
                <c:pt idx="23">
                  <c:v>8.2527E-005</c:v>
                </c:pt>
                <c:pt idx="24">
                  <c:v>8.7156E-005</c:v>
                </c:pt>
                <c:pt idx="25">
                  <c:v>9.202E-005</c:v>
                </c:pt>
                <c:pt idx="26">
                  <c:v>9.7127E-005</c:v>
                </c:pt>
                <c:pt idx="27">
                  <c:v>0.00010249</c:v>
                </c:pt>
                <c:pt idx="28">
                  <c:v>0.0001081</c:v>
                </c:pt>
                <c:pt idx="29">
                  <c:v>0.00011399</c:v>
                </c:pt>
                <c:pt idx="30">
                  <c:v>0.00012014</c:v>
                </c:pt>
                <c:pt idx="31">
                  <c:v>0.00012658</c:v>
                </c:pt>
                <c:pt idx="32">
                  <c:v>0.00013331</c:v>
                </c:pt>
                <c:pt idx="33">
                  <c:v>0.00014032</c:v>
                </c:pt>
                <c:pt idx="34">
                  <c:v>0.00014764</c:v>
                </c:pt>
                <c:pt idx="35">
                  <c:v>0.00015526</c:v>
                </c:pt>
                <c:pt idx="36">
                  <c:v>0.00016319</c:v>
                </c:pt>
                <c:pt idx="37">
                  <c:v>0.00017143</c:v>
                </c:pt>
                <c:pt idx="38">
                  <c:v>0.00017998</c:v>
                </c:pt>
                <c:pt idx="39">
                  <c:v>0.00018886</c:v>
                </c:pt>
                <c:pt idx="40">
                  <c:v>0.00019807</c:v>
                </c:pt>
                <c:pt idx="41">
                  <c:v>0.00020761</c:v>
                </c:pt>
                <c:pt idx="42">
                  <c:v>0.00021749</c:v>
                </c:pt>
                <c:pt idx="43">
                  <c:v>0.00022773</c:v>
                </c:pt>
                <c:pt idx="44">
                  <c:v>0.00023833</c:v>
                </c:pt>
                <c:pt idx="45">
                  <c:v>0.0002493</c:v>
                </c:pt>
                <c:pt idx="46">
                  <c:v>0.00026069</c:v>
                </c:pt>
                <c:pt idx="47">
                  <c:v>0.00027251</c:v>
                </c:pt>
                <c:pt idx="48">
                  <c:v>0.0002848</c:v>
                </c:pt>
                <c:pt idx="49">
                  <c:v>0.00029763</c:v>
                </c:pt>
                <c:pt idx="50">
                  <c:v>0.00031105</c:v>
                </c:pt>
                <c:pt idx="51">
                  <c:v>0.00032515</c:v>
                </c:pt>
                <c:pt idx="52">
                  <c:v>0.00034006</c:v>
                </c:pt>
                <c:pt idx="53">
                  <c:v>0.00035593</c:v>
                </c:pt>
                <c:pt idx="54">
                  <c:v>0.00037294</c:v>
                </c:pt>
                <c:pt idx="55">
                  <c:v>0.00039134</c:v>
                </c:pt>
                <c:pt idx="56">
                  <c:v>0.00041146</c:v>
                </c:pt>
                <c:pt idx="57">
                  <c:v>0.00043371</c:v>
                </c:pt>
                <c:pt idx="58">
                  <c:v>0.00045864</c:v>
                </c:pt>
                <c:pt idx="59">
                  <c:v>0.00048693</c:v>
                </c:pt>
                <c:pt idx="60">
                  <c:v>0.00051952</c:v>
                </c:pt>
                <c:pt idx="61">
                  <c:v>0.00055762</c:v>
                </c:pt>
                <c:pt idx="62">
                  <c:v>0.00060281</c:v>
                </c:pt>
                <c:pt idx="63">
                  <c:v>0.00065725</c:v>
                </c:pt>
                <c:pt idx="64">
                  <c:v>0.0007238</c:v>
                </c:pt>
                <c:pt idx="65">
                  <c:v>0.00080637</c:v>
                </c:pt>
                <c:pt idx="66">
                  <c:v>0.00091034</c:v>
                </c:pt>
                <c:pt idx="67">
                  <c:v>0.0010432</c:v>
                </c:pt>
                <c:pt idx="68">
                  <c:v>0.0012155</c:v>
                </c:pt>
                <c:pt idx="69">
                  <c:v>0.0014423</c:v>
                </c:pt>
                <c:pt idx="70">
                  <c:v>0.0017458</c:v>
                </c:pt>
                <c:pt idx="71">
                  <c:v>0.0021584</c:v>
                </c:pt>
                <c:pt idx="72">
                  <c:v>0.0027283</c:v>
                </c:pt>
                <c:pt idx="73">
                  <c:v>0.0035275</c:v>
                </c:pt>
                <c:pt idx="74">
                  <c:v>0.0046618</c:v>
                </c:pt>
                <c:pt idx="75">
                  <c:v>0.0062807</c:v>
                </c:pt>
                <c:pt idx="76">
                  <c:v>0.0085777</c:v>
                </c:pt>
                <c:pt idx="77">
                  <c:v>0.011759</c:v>
                </c:pt>
                <c:pt idx="78">
                  <c:v>0.015965</c:v>
                </c:pt>
                <c:pt idx="79">
                  <c:v>0.021384</c:v>
                </c:pt>
                <c:pt idx="80">
                  <c:v>0.030447</c:v>
                </c:pt>
                <c:pt idx="81">
                  <c:v>0.061389</c:v>
                </c:pt>
                <c:pt idx="82">
                  <c:v>0.15323</c:v>
                </c:pt>
                <c:pt idx="83">
                  <c:v>0.16678</c:v>
                </c:pt>
                <c:pt idx="84">
                  <c:v>0.091105</c:v>
                </c:pt>
                <c:pt idx="85">
                  <c:v>0.099272</c:v>
                </c:pt>
                <c:pt idx="86">
                  <c:v>0.10592</c:v>
                </c:pt>
                <c:pt idx="87">
                  <c:v>0.062922</c:v>
                </c:pt>
                <c:pt idx="88">
                  <c:v>0.031163</c:v>
                </c:pt>
                <c:pt idx="89">
                  <c:v>0.018887</c:v>
                </c:pt>
                <c:pt idx="90">
                  <c:v>0.013542</c:v>
                </c:pt>
                <c:pt idx="91">
                  <c:v>0.010177</c:v>
                </c:pt>
                <c:pt idx="92">
                  <c:v>0.0076716</c:v>
                </c:pt>
                <c:pt idx="93">
                  <c:v>0.0057918</c:v>
                </c:pt>
                <c:pt idx="94">
                  <c:v>0.004417</c:v>
                </c:pt>
                <c:pt idx="95">
                  <c:v>0.0034284</c:v>
                </c:pt>
                <c:pt idx="96">
                  <c:v>0.0027193</c:v>
                </c:pt>
                <c:pt idx="97">
                  <c:v>0.0022055</c:v>
                </c:pt>
                <c:pt idx="98">
                  <c:v>0.0018265</c:v>
                </c:pt>
                <c:pt idx="99">
                  <c:v>0.0015406</c:v>
                </c:pt>
              </c:numCache>
            </c:numRef>
          </c:val>
          <c:smooth val="0"/>
        </c:ser>
        <c:hiLowLines>
          <c:spPr>
            <a:ln w="0">
              <a:noFill/>
            </a:ln>
          </c:spPr>
        </c:hiLowLines>
        <c:marker val="0"/>
        <c:axId val="21808307"/>
        <c:axId val="93005503"/>
      </c:lineChart>
      <c:catAx>
        <c:axId val="21808307"/>
        <c:scaling>
          <c:orientation val="minMax"/>
        </c:scaling>
        <c:delete val="0"/>
        <c:axPos val="b"/>
        <c:title>
          <c:tx>
            <c:rich>
              <a:bodyPr rot="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Temperature (ºC)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 rot="-2700000"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93005503"/>
        <c:crosses val="autoZero"/>
        <c:auto val="1"/>
        <c:lblAlgn val="ctr"/>
        <c:lblOffset val="100"/>
        <c:noMultiLvlLbl val="0"/>
      </c:catAx>
      <c:valAx>
        <c:axId val="93005503"/>
        <c:scaling>
          <c:orientation val="minMax"/>
          <c:max val="0.3"/>
          <c:min val="0"/>
        </c:scaling>
        <c:delete val="0"/>
        <c:axPos val="l"/>
        <c:majorGridlines>
          <c:spPr>
            <a:ln w="0">
              <a:solidFill>
                <a:srgbClr val="b3b3b3"/>
              </a:solidFill>
            </a:ln>
          </c:spPr>
        </c:majorGridlines>
        <c:title>
          <c:tx>
            <c:rich>
              <a:bodyPr rot="-5400000"/>
              <a:lstStyle/>
              <a:p>
                <a:pPr>
                  <a:defRPr b="0" sz="2000" spc="-1" strike="noStrike">
                    <a:solidFill>
                      <a:srgbClr val="000000"/>
                    </a:solidFill>
                    <a:latin typeface="Arial"/>
                  </a:defRPr>
                </a:pPr>
                <a:r>
                  <a:rPr b="0" sz="2000" spc="-1" strike="noStrike">
                    <a:solidFill>
                      <a:srgbClr val="000000"/>
                    </a:solidFill>
                    <a:latin typeface="Arial"/>
                  </a:rPr>
                  <a:t>dθ/dT</a:t>
                </a:r>
              </a:p>
            </c:rich>
          </c:tx>
          <c:overlay val="0"/>
          <c:spPr>
            <a:noFill/>
            <a:ln w="0">
              <a:noFill/>
            </a:ln>
          </c:spPr>
        </c:title>
        <c:numFmt formatCode="General" sourceLinked="0"/>
        <c:majorTickMark val="out"/>
        <c:minorTickMark val="none"/>
        <c:tickLblPos val="nextTo"/>
        <c:spPr>
          <a:ln w="0">
            <a:solidFill>
              <a:srgbClr val="b3b3b3"/>
            </a:solidFill>
          </a:ln>
        </c:spPr>
        <c:txPr>
          <a:bodyPr/>
          <a:lstStyle/>
          <a:p>
            <a:pPr>
              <a:defRPr b="0" sz="2000" spc="-1" strike="noStrike">
                <a:solidFill>
                  <a:srgbClr val="000000"/>
                </a:solidFill>
                <a:latin typeface="Arial"/>
              </a:defRPr>
            </a:pPr>
          </a:p>
        </c:txPr>
        <c:crossAx val="21808307"/>
        <c:crosses val="autoZero"/>
        <c:crossBetween val="midCat"/>
      </c:valAx>
      <c:spPr>
        <a:noFill/>
        <a:ln w="0">
          <a:solidFill>
            <a:srgbClr val="b3b3b3"/>
          </a:solidFill>
        </a:ln>
      </c:spPr>
    </c:plotArea>
    <c:plotVisOnly val="1"/>
    <c:dispBlanksAs val="gap"/>
  </c:chart>
  <c:spPr>
    <a:solidFill>
      <a:srgbClr val="ffffff"/>
    </a:solidFill>
    <a:ln w="0">
      <a:noFill/>
    </a:ln>
  </c:spPr>
</c:chartSpace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AutoShape 1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AutoShape 2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4" name="AutoShape 3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5" name="AutoShape 4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" name="AutoShape 5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" name="AutoShape 6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" name="AutoShape 7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" name="AutoShape 8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" name="AutoShape 9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AutoShape 10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" name="AutoShape 11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" name="AutoShape 12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" name="AutoShape 13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" name="AutoShape 14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" name="PlaceHolder 1"/>
          <p:cNvSpPr>
            <a:spLocks noGrp="1"/>
          </p:cNvSpPr>
          <p:nvPr>
            <p:ph type="sldImg"/>
          </p:nvPr>
        </p:nvSpPr>
        <p:spPr>
          <a:xfrm>
            <a:off x="-8688600" y="-15185880"/>
            <a:ext cx="24910920" cy="35980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58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2"/>
          <p:cNvSpPr>
            <a:spLocks noGrp="1"/>
          </p:cNvSpPr>
          <p:nvPr>
            <p:ph type="body"/>
          </p:nvPr>
        </p:nvSpPr>
        <p:spPr>
          <a:xfrm>
            <a:off x="755280" y="5078160"/>
            <a:ext cx="6024600" cy="4787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74"/>
              </a:spcBef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Text Box 17"/>
          <p:cNvSpPr/>
          <p:nvPr/>
        </p:nvSpPr>
        <p:spPr>
          <a:xfrm>
            <a:off x="0" y="0"/>
            <a:ext cx="3276720" cy="530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9" name="Text Box 18"/>
          <p:cNvSpPr/>
          <p:nvPr/>
        </p:nvSpPr>
        <p:spPr>
          <a:xfrm>
            <a:off x="4278240" y="0"/>
            <a:ext cx="3276720" cy="530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Text Box 19"/>
          <p:cNvSpPr/>
          <p:nvPr/>
        </p:nvSpPr>
        <p:spPr>
          <a:xfrm>
            <a:off x="0" y="10155240"/>
            <a:ext cx="3276720" cy="530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sldNum" idx="2"/>
          </p:nvPr>
        </p:nvSpPr>
        <p:spPr>
          <a:xfrm>
            <a:off x="4277880" y="10155240"/>
            <a:ext cx="3257640" cy="511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001080"/>
                <a:tab algn="l" pos="9086760"/>
                <a:tab algn="l" pos="9172440"/>
                <a:tab algn="l" pos="9258480"/>
                <a:tab algn="l" pos="9344160"/>
                <a:tab algn="l" pos="9429840"/>
                <a:tab algn="l" pos="9515520"/>
                <a:tab algn="l" pos="9601200"/>
                <a:tab algn="l" pos="9686880"/>
                <a:tab algn="l" pos="9772560"/>
                <a:tab algn="l" pos="9858240"/>
                <a:tab algn="l" pos="9944280"/>
                <a:tab algn="l" pos="10029960"/>
                <a:tab algn="l" pos="10115640"/>
                <a:tab algn="l" pos="10201320"/>
                <a:tab algn="l" pos="10287000"/>
                <a:tab algn="l" pos="10372680"/>
                <a:tab algn="l" pos="10458360"/>
                <a:tab algn="l" pos="10544040"/>
                <a:tab algn="l" pos="10630080"/>
              </a:tabLst>
              <a:defRPr b="0" lang="pt-B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001080"/>
                <a:tab algn="l" pos="9086760"/>
                <a:tab algn="l" pos="9172440"/>
                <a:tab algn="l" pos="9258480"/>
                <a:tab algn="l" pos="9344160"/>
                <a:tab algn="l" pos="9429840"/>
                <a:tab algn="l" pos="9515520"/>
                <a:tab algn="l" pos="9601200"/>
                <a:tab algn="l" pos="9686880"/>
                <a:tab algn="l" pos="9772560"/>
                <a:tab algn="l" pos="9858240"/>
                <a:tab algn="l" pos="9944280"/>
                <a:tab algn="l" pos="10029960"/>
                <a:tab algn="l" pos="10115640"/>
                <a:tab algn="l" pos="10201320"/>
                <a:tab algn="l" pos="10287000"/>
                <a:tab algn="l" pos="10372680"/>
                <a:tab algn="l" pos="10458360"/>
                <a:tab algn="l" pos="10544040"/>
                <a:tab algn="l" pos="10630080"/>
              </a:tabLst>
            </a:pPr>
            <a:fld id="{5294D02D-3C4F-4A10-ADB5-0AB2431982B0}" type="slidenum">
              <a:rPr b="0" lang="pt-B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Rectangle 20"/>
          <p:cNvSpPr/>
          <p:nvPr/>
        </p:nvSpPr>
        <p:spPr>
          <a:xfrm>
            <a:off x="4278240" y="10155240"/>
            <a:ext cx="325764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001080"/>
                <a:tab algn="l" pos="9086760"/>
                <a:tab algn="l" pos="9172440"/>
                <a:tab algn="l" pos="9258480"/>
                <a:tab algn="l" pos="9344160"/>
                <a:tab algn="l" pos="9429840"/>
                <a:tab algn="l" pos="9515520"/>
                <a:tab algn="l" pos="9601200"/>
                <a:tab algn="l" pos="9686880"/>
                <a:tab algn="l" pos="9772560"/>
                <a:tab algn="l" pos="9858240"/>
                <a:tab algn="l" pos="9944280"/>
                <a:tab algn="l" pos="10029960"/>
                <a:tab algn="l" pos="10115640"/>
                <a:tab algn="l" pos="10201320"/>
                <a:tab algn="l" pos="10287000"/>
                <a:tab algn="l" pos="10372680"/>
                <a:tab algn="l" pos="10458360"/>
                <a:tab algn="l" pos="10544040"/>
                <a:tab algn="l" pos="10630080"/>
              </a:tabLst>
            </a:pPr>
            <a:fld id="{0341106E-E3F6-4339-B74B-CF499C444E95}" type="slidenum">
              <a:rPr b="0" lang="pt-B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" name="Text Box 1"/>
          <p:cNvSpPr/>
          <p:nvPr/>
        </p:nvSpPr>
        <p:spPr>
          <a:xfrm>
            <a:off x="4278240" y="10155240"/>
            <a:ext cx="3260880" cy="51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9001080"/>
                <a:tab algn="l" pos="9086760"/>
                <a:tab algn="l" pos="9172440"/>
                <a:tab algn="l" pos="9258480"/>
                <a:tab algn="l" pos="9344160"/>
                <a:tab algn="l" pos="9429840"/>
                <a:tab algn="l" pos="9515520"/>
                <a:tab algn="l" pos="9601200"/>
                <a:tab algn="l" pos="9686880"/>
                <a:tab algn="l" pos="9772560"/>
                <a:tab algn="l" pos="9858240"/>
                <a:tab algn="l" pos="9944280"/>
                <a:tab algn="l" pos="10029960"/>
                <a:tab algn="l" pos="10115640"/>
                <a:tab algn="l" pos="10201320"/>
                <a:tab algn="l" pos="10287000"/>
                <a:tab algn="l" pos="10372680"/>
                <a:tab algn="l" pos="10458360"/>
                <a:tab algn="l" pos="10544040"/>
                <a:tab algn="l" pos="10630080"/>
              </a:tabLst>
            </a:pPr>
            <a:fld id="{3B83A011-0EAB-4D4A-A184-244593F1E07E}" type="slidenum">
              <a:rPr b="0" lang="pt-B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4" name="PlaceHolder 1"/>
          <p:cNvSpPr>
            <a:spLocks noGrp="1"/>
          </p:cNvSpPr>
          <p:nvPr>
            <p:ph type="sldImg"/>
          </p:nvPr>
        </p:nvSpPr>
        <p:spPr>
          <a:xfrm>
            <a:off x="2392200" y="812880"/>
            <a:ext cx="2773440" cy="4008240"/>
          </a:xfrm>
          <a:prstGeom prst="rect">
            <a:avLst/>
          </a:prstGeom>
          <a:ln w="0">
            <a:noFill/>
          </a:ln>
        </p:spPr>
      </p:sp>
      <p:sp>
        <p:nvSpPr>
          <p:cNvPr id="85" name="Text Box 3"/>
          <p:cNvSpPr/>
          <p:nvPr/>
        </p:nvSpPr>
        <p:spPr>
          <a:xfrm>
            <a:off x="755640" y="5078520"/>
            <a:ext cx="6048360" cy="4811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 type="body"/>
          </p:nvPr>
        </p:nvSpPr>
        <p:spPr>
          <a:xfrm>
            <a:off x="755280" y="5078160"/>
            <a:ext cx="6024600" cy="4787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74"/>
              </a:spcBef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401E997-602C-4631-8FD1-9A273A4138AE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61671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975280"/>
            <a:ext cx="61671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7321B283-BAC2-4189-A8A0-D29AC376EDEB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800" y="231732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97528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800" y="597528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92AD86D-F4B3-47BE-9169-4E5F2117F09B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19857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8200" y="2317320"/>
            <a:ext cx="19857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3680" y="2317320"/>
            <a:ext cx="19857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975280"/>
            <a:ext cx="19857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8200" y="5975280"/>
            <a:ext cx="19857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3680" y="5975280"/>
            <a:ext cx="19857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2709029-1AE1-41AF-A437-99CEED43014D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7320"/>
            <a:ext cx="616716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2AB68A4-0FB3-41CE-81C2-CCECC859B4CD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616716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37BDF616-8F00-4ECA-BCEF-98502F268BED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300924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800" y="2317320"/>
            <a:ext cx="300924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A0219A2-7912-4B5D-A564-8290B9471234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353A1E6-48E0-4A11-BC5A-BFE1D43A9E19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-4680"/>
            <a:ext cx="6167160" cy="11361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Aft>
                <a:spcPts val="1862"/>
              </a:spcAft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01A29409-2C42-43FD-BC08-F9C06FCC24B9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800" y="2317320"/>
            <a:ext cx="300924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97528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783083C-183A-4AC7-8E24-0F8F33456011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300924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800" y="231732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800" y="597528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47B8271F-CBF5-4E79-8C19-097A0EA57B01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732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800" y="2317320"/>
            <a:ext cx="300924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975280"/>
            <a:ext cx="6167160" cy="334008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FE91767-B61D-49BC-9D3B-1CD6CF6A07DC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-4680"/>
            <a:ext cx="6167160" cy="2450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58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5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7320"/>
            <a:ext cx="6167160" cy="7002360"/>
          </a:xfrm>
          <a:prstGeom prst="rect">
            <a:avLst/>
          </a:prstGeom>
          <a:noFill/>
          <a:ln w="0">
            <a:noFill/>
          </a:ln>
        </p:spPr>
        <p:txBody>
          <a:bodyPr lIns="0" rIns="0" tIns="37080" bIns="0" anchor="t">
            <a:normAutofit/>
          </a:bodyPr>
          <a:p>
            <a:pPr marL="65160" indent="0">
              <a:lnSpc>
                <a:spcPct val="93000"/>
              </a:lnSpc>
              <a:spcAft>
                <a:spcPts val="1862"/>
              </a:spcAft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1" marL="65160" indent="-65160">
              <a:lnSpc>
                <a:spcPct val="93000"/>
              </a:lnSpc>
              <a:spcAft>
                <a:spcPts val="1862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2" marL="65160" indent="-65160">
              <a:lnSpc>
                <a:spcPct val="93000"/>
              </a:lnSpc>
              <a:spcAft>
                <a:spcPts val="1862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3" marL="65160" indent="-65160">
              <a:lnSpc>
                <a:spcPct val="93000"/>
              </a:lnSpc>
              <a:spcAft>
                <a:spcPts val="1862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4" marL="65160" indent="-65160">
              <a:lnSpc>
                <a:spcPct val="93000"/>
              </a:lnSpc>
              <a:spcAft>
                <a:spcPts val="1862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5" marL="65160" indent="-65160">
              <a:lnSpc>
                <a:spcPct val="93000"/>
              </a:lnSpc>
              <a:spcAft>
                <a:spcPts val="1862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  <a:p>
            <a:pPr lvl="6" marL="65160" indent="-65160">
              <a:lnSpc>
                <a:spcPct val="93000"/>
              </a:lnSpc>
              <a:spcAft>
                <a:spcPts val="1862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4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Text Box 3"/>
          <p:cNvSpPr/>
          <p:nvPr/>
        </p:nvSpPr>
        <p:spPr>
          <a:xfrm>
            <a:off x="343080" y="9024840"/>
            <a:ext cx="1596960" cy="68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7640" rIns="17640" tIns="9000" bIns="90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Text Box 4"/>
          <p:cNvSpPr/>
          <p:nvPr/>
        </p:nvSpPr>
        <p:spPr>
          <a:xfrm>
            <a:off x="2344680" y="9024840"/>
            <a:ext cx="2173320" cy="68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17640" rIns="17640" tIns="9000" bIns="90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4917600" y="9024480"/>
            <a:ext cx="1592280" cy="677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  <a:defRPr b="0" lang="pt-BR" sz="1800" spc="-1" strike="noStrike">
                <a:solidFill>
                  <a:srgbClr val="ffffff"/>
                </a:solidFill>
                <a:latin typeface="Arial"/>
              </a:defRPr>
            </a:lvl1pPr>
          </a:lstStyle>
          <a:p>
            <a:pPr indent="0">
              <a:lnSpc>
                <a:spcPct val="93000"/>
              </a:lnSpc>
              <a:buNone/>
              <a:tabLst>
                <a:tab algn="l" pos="0"/>
                <a:tab algn="l" pos="85680"/>
                <a:tab algn="l" pos="171360"/>
                <a:tab algn="l" pos="257040"/>
                <a:tab algn="l" pos="343080"/>
                <a:tab algn="l" pos="428760"/>
                <a:tab algn="l" pos="514440"/>
                <a:tab algn="l" pos="600120"/>
                <a:tab algn="l" pos="685800"/>
                <a:tab algn="l" pos="771480"/>
                <a:tab algn="l" pos="857160"/>
                <a:tab algn="l" pos="942840"/>
                <a:tab algn="l" pos="1028880"/>
                <a:tab algn="l" pos="1114560"/>
                <a:tab algn="l" pos="1200240"/>
                <a:tab algn="l" pos="1285920"/>
                <a:tab algn="l" pos="1371600"/>
                <a:tab algn="l" pos="1457280"/>
                <a:tab algn="l" pos="1542960"/>
                <a:tab algn="l" pos="1628640"/>
                <a:tab algn="l" pos="1714680"/>
              </a:tabLst>
            </a:pPr>
            <a:fld id="{A020D1CF-CABE-49DD-AE3B-401A49A2BE2E}" type="slidenum">
              <a:rPr b="0" lang="pt-BR" sz="1800" spc="-1" strike="noStrike">
                <a:solidFill>
                  <a:srgbClr val="ffffff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chart" Target="../charts/chart1.xml"/><Relationship Id="rId2" Type="http://schemas.openxmlformats.org/officeDocument/2006/relationships/chart" Target="../charts/chart2.xml"/><Relationship Id="rId3" Type="http://schemas.openxmlformats.org/officeDocument/2006/relationships/chart" Target="../charts/chart3.xml"/><Relationship Id="rId4" Type="http://schemas.openxmlformats.org/officeDocument/2006/relationships/image" Target="../media/image1.png"/><Relationship Id="rId5" Type="http://schemas.openxmlformats.org/officeDocument/2006/relationships/image" Target="../media/image2.png"/><Relationship Id="rId6" Type="http://schemas.openxmlformats.org/officeDocument/2006/relationships/image" Target="../media/image3.png"/><Relationship Id="rId7" Type="http://schemas.openxmlformats.org/officeDocument/2006/relationships/chart" Target="../charts/chart4.xml"/><Relationship Id="rId8" Type="http://schemas.openxmlformats.org/officeDocument/2006/relationships/chart" Target="../charts/chart5.xml"/><Relationship Id="rId9" Type="http://schemas.openxmlformats.org/officeDocument/2006/relationships/chart" Target="../charts/chart6.xml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2" name="Object 4"/>
          <p:cNvGraphicFramePr/>
          <p:nvPr/>
        </p:nvGraphicFramePr>
        <p:xfrm>
          <a:off x="2708280" y="1424160"/>
          <a:ext cx="1930320" cy="13381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63" name="Object 5"/>
          <p:cNvGraphicFramePr/>
          <p:nvPr/>
        </p:nvGraphicFramePr>
        <p:xfrm>
          <a:off x="2708280" y="2730600"/>
          <a:ext cx="1944720" cy="13586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4" name="Object 6"/>
          <p:cNvGraphicFramePr/>
          <p:nvPr/>
        </p:nvGraphicFramePr>
        <p:xfrm>
          <a:off x="2708280" y="4089240"/>
          <a:ext cx="1944720" cy="14194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65" name="Picture 7" descr=""/>
          <p:cNvPicPr/>
          <p:nvPr/>
        </p:nvPicPr>
        <p:blipFill>
          <a:blip r:embed="rId4"/>
          <a:stretch/>
        </p:blipFill>
        <p:spPr>
          <a:xfrm>
            <a:off x="1639800" y="1598760"/>
            <a:ext cx="781200" cy="90648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8" descr=""/>
          <p:cNvPicPr/>
          <p:nvPr/>
        </p:nvPicPr>
        <p:blipFill>
          <a:blip r:embed="rId5"/>
          <a:stretch/>
        </p:blipFill>
        <p:spPr>
          <a:xfrm>
            <a:off x="1738440" y="2797200"/>
            <a:ext cx="610920" cy="100332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9" descr=""/>
          <p:cNvPicPr/>
          <p:nvPr/>
        </p:nvPicPr>
        <p:blipFill>
          <a:blip r:embed="rId6"/>
          <a:stretch/>
        </p:blipFill>
        <p:spPr>
          <a:xfrm>
            <a:off x="1916280" y="4160880"/>
            <a:ext cx="504720" cy="12859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68" name="Object 10"/>
          <p:cNvGraphicFramePr/>
          <p:nvPr/>
        </p:nvGraphicFramePr>
        <p:xfrm>
          <a:off x="4673520" y="1440000"/>
          <a:ext cx="1924200" cy="1352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69" name="Object 11"/>
          <p:cNvGraphicFramePr/>
          <p:nvPr/>
        </p:nvGraphicFramePr>
        <p:xfrm>
          <a:off x="4643280" y="2720880"/>
          <a:ext cx="1976760" cy="14065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70" name="Object 12"/>
          <p:cNvGraphicFramePr/>
          <p:nvPr/>
        </p:nvGraphicFramePr>
        <p:xfrm>
          <a:off x="4635360" y="4113360"/>
          <a:ext cx="1998720" cy="14205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71" name="Text Box 13"/>
          <p:cNvSpPr/>
          <p:nvPr/>
        </p:nvSpPr>
        <p:spPr>
          <a:xfrm>
            <a:off x="0" y="425520"/>
            <a:ext cx="6858000" cy="34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24120"/>
                <a:tab algn="l" pos="1911240"/>
                <a:tab algn="l" pos="1996920"/>
                <a:tab algn="l" pos="2084400"/>
                <a:tab algn="l" pos="2171880"/>
                <a:tab algn="l" pos="2259000"/>
                <a:tab algn="l" pos="2344680"/>
                <a:tab algn="l" pos="2432160"/>
                <a:tab algn="l" pos="2519280"/>
                <a:tab algn="l" pos="260496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  <a:tab algn="l" pos="3514680"/>
                <a:tab algn="l" pos="3600360"/>
                <a:tab algn="l" pos="3686040"/>
                <a:tab algn="l" pos="3772080"/>
                <a:tab algn="l" pos="3857760"/>
                <a:tab algn="l" pos="3943440"/>
                <a:tab algn="l" pos="4029120"/>
                <a:tab algn="l" pos="4114800"/>
                <a:tab algn="l" pos="4200480"/>
                <a:tab algn="l" pos="4286160"/>
              </a:tabLst>
            </a:pP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Group GLV-like</a:t>
            </a:r>
            <a:endParaRPr b="0" lang="en-US" sz="1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2" name="Text Box 14"/>
          <p:cNvSpPr/>
          <p:nvPr/>
        </p:nvSpPr>
        <p:spPr>
          <a:xfrm>
            <a:off x="557280" y="993600"/>
            <a:ext cx="1225440" cy="28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" name="Text Box 15"/>
          <p:cNvSpPr/>
          <p:nvPr/>
        </p:nvSpPr>
        <p:spPr>
          <a:xfrm>
            <a:off x="1916280" y="992160"/>
            <a:ext cx="122544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4" name="Text Box 16"/>
          <p:cNvSpPr/>
          <p:nvPr/>
        </p:nvSpPr>
        <p:spPr>
          <a:xfrm>
            <a:off x="3573360" y="993600"/>
            <a:ext cx="1225800" cy="28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5" name="Text Box 17"/>
          <p:cNvSpPr/>
          <p:nvPr/>
        </p:nvSpPr>
        <p:spPr>
          <a:xfrm>
            <a:off x="5516640" y="1006560"/>
            <a:ext cx="122544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6" name="Text Box 18"/>
          <p:cNvSpPr/>
          <p:nvPr/>
        </p:nvSpPr>
        <p:spPr>
          <a:xfrm>
            <a:off x="2932200" y="1292400"/>
            <a:ext cx="1596960" cy="202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9000" bIns="90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1" lang="pt-BR" sz="1300" spc="-1" strike="noStrike">
                <a:solidFill>
                  <a:srgbClr val="000000"/>
                </a:solidFill>
                <a:latin typeface="Arial"/>
              </a:rPr>
              <a:t>RNAheat</a:t>
            </a:r>
            <a:endParaRPr b="0" lang="en-US" sz="13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7" name="Text Box 19"/>
          <p:cNvSpPr/>
          <p:nvPr/>
        </p:nvSpPr>
        <p:spPr>
          <a:xfrm>
            <a:off x="4941720" y="1292400"/>
            <a:ext cx="1568520" cy="202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9000" bIns="90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1" lang="pt-BR" sz="1300" spc="-1" strike="noStrike">
                <a:solidFill>
                  <a:srgbClr val="000000"/>
                </a:solidFill>
                <a:latin typeface="Arial"/>
              </a:rPr>
              <a:t>Meltsim</a:t>
            </a:r>
            <a:endParaRPr b="0" lang="en-US" sz="13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8" name="Text Box 20"/>
          <p:cNvSpPr/>
          <p:nvPr/>
        </p:nvSpPr>
        <p:spPr>
          <a:xfrm>
            <a:off x="0" y="5889600"/>
            <a:ext cx="6858000" cy="28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9000" bIns="90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24120"/>
                <a:tab algn="l" pos="1911240"/>
                <a:tab algn="l" pos="1996920"/>
                <a:tab algn="l" pos="2084400"/>
                <a:tab algn="l" pos="2171880"/>
                <a:tab algn="l" pos="2259000"/>
                <a:tab algn="l" pos="2344680"/>
                <a:tab algn="l" pos="2432160"/>
                <a:tab algn="l" pos="2519280"/>
                <a:tab algn="l" pos="260496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  <a:tab algn="l" pos="3514680"/>
                <a:tab algn="l" pos="3600360"/>
                <a:tab algn="l" pos="3686040"/>
                <a:tab algn="l" pos="3772080"/>
                <a:tab algn="l" pos="3857760"/>
                <a:tab algn="l" pos="3943440"/>
                <a:tab algn="l" pos="4029120"/>
                <a:tab algn="l" pos="4114800"/>
                <a:tab algn="l" pos="4200480"/>
                <a:tab algn="l" pos="4286160"/>
              </a:tabLst>
            </a:pPr>
            <a:r>
              <a:rPr b="0" lang="pt-BR" sz="1900" spc="-1" strike="noStrike">
                <a:solidFill>
                  <a:srgbClr val="000000"/>
                </a:solidFill>
                <a:latin typeface="Arial"/>
              </a:rPr>
              <a:t>Supplementary figure 1  </a:t>
            </a:r>
            <a:endParaRPr b="0" lang="en-US" sz="19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" name="Text Box 1"/>
          <p:cNvSpPr/>
          <p:nvPr/>
        </p:nvSpPr>
        <p:spPr>
          <a:xfrm>
            <a:off x="115920" y="1871640"/>
            <a:ext cx="119700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i="1" lang="pt-BR" sz="800" spc="-1" strike="noStrike">
                <a:solidFill>
                  <a:srgbClr val="000000"/>
                </a:solidFill>
                <a:latin typeface="Arial"/>
              </a:rPr>
              <a:t>Giardia lamblia virus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GI: 20143439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Nt: 5151 </a:t>
            </a:r>
            <a:r>
              <a:rPr b="0" lang="pt-BR" sz="8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 5350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" name="Text Box 2"/>
          <p:cNvSpPr/>
          <p:nvPr/>
        </p:nvSpPr>
        <p:spPr>
          <a:xfrm>
            <a:off x="125280" y="3192480"/>
            <a:ext cx="1503360" cy="4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i="1" lang="pt-BR" sz="800" spc="-1" strike="noStrike">
                <a:solidFill>
                  <a:srgbClr val="000000"/>
                </a:solidFill>
                <a:latin typeface="Arial"/>
              </a:rPr>
              <a:t>Giardia canis virus from China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GI: 78217291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Nt: 5154 </a:t>
            </a:r>
            <a:r>
              <a:rPr b="0" lang="pt-BR" sz="8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 5353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" name="Text Box 3"/>
          <p:cNvSpPr/>
          <p:nvPr/>
        </p:nvSpPr>
        <p:spPr>
          <a:xfrm>
            <a:off x="115920" y="4567320"/>
            <a:ext cx="1747800" cy="47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17280" rIns="17280" tIns="8640" bIns="86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i="1" lang="pt-BR" sz="800" spc="-1" strike="noStrike">
                <a:solidFill>
                  <a:srgbClr val="000000"/>
                </a:solidFill>
                <a:latin typeface="Arial"/>
              </a:rPr>
              <a:t>Piscine myocarditis virus AL V-708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GI: 336042307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85680"/>
                <a:tab algn="l" pos="173160"/>
                <a:tab algn="l" pos="260280"/>
                <a:tab algn="l" pos="345960"/>
                <a:tab algn="l" pos="433440"/>
                <a:tab algn="l" pos="520560"/>
                <a:tab algn="l" pos="606600"/>
                <a:tab algn="l" pos="693720"/>
                <a:tab algn="l" pos="781200"/>
                <a:tab algn="l" pos="868320"/>
                <a:tab algn="l" pos="954000"/>
                <a:tab algn="l" pos="1041480"/>
                <a:tab algn="l" pos="1128600"/>
                <a:tab algn="l" pos="1216080"/>
                <a:tab algn="l" pos="1301760"/>
                <a:tab algn="l" pos="1389240"/>
                <a:tab algn="l" pos="1476360"/>
                <a:tab algn="l" pos="1562040"/>
                <a:tab algn="l" pos="1649520"/>
                <a:tab algn="l" pos="1736640"/>
                <a:tab algn="l" pos="1800360"/>
                <a:tab algn="l" pos="1886040"/>
                <a:tab algn="l" pos="1971720"/>
                <a:tab algn="l" pos="2057400"/>
                <a:tab algn="l" pos="2143080"/>
                <a:tab algn="l" pos="2228760"/>
                <a:tab algn="l" pos="2314440"/>
                <a:tab algn="l" pos="2400480"/>
                <a:tab algn="l" pos="2486160"/>
                <a:tab algn="l" pos="2571840"/>
                <a:tab algn="l" pos="2657520"/>
                <a:tab algn="l" pos="2743200"/>
                <a:tab algn="l" pos="2828880"/>
                <a:tab algn="l" pos="2914560"/>
                <a:tab algn="l" pos="3000240"/>
                <a:tab algn="l" pos="3086280"/>
                <a:tab algn="l" pos="3171960"/>
                <a:tab algn="l" pos="3257640"/>
                <a:tab algn="l" pos="3343320"/>
                <a:tab algn="l" pos="3429000"/>
              </a:tabLst>
            </a:pP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Nt: 4663 </a:t>
            </a:r>
            <a:r>
              <a:rPr b="0" lang="pt-BR" sz="800" spc="-1" strike="noStrike">
                <a:solidFill>
                  <a:srgbClr val="000000"/>
                </a:solidFill>
                <a:latin typeface="Wingdings"/>
                <a:ea typeface="Wingdings"/>
              </a:rPr>
              <a:t></a:t>
            </a:r>
            <a:r>
              <a:rPr b="0" lang="pt-BR" sz="800" spc="-1" strike="noStrike">
                <a:solidFill>
                  <a:srgbClr val="000000"/>
                </a:solidFill>
                <a:latin typeface="Arial"/>
              </a:rPr>
              <a:t> 4818</a:t>
            </a:r>
            <a:endParaRPr b="0" lang="en-US" sz="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51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09T20:45:45Z</dcterms:created>
  <dc:creator>Raffael</dc:creator>
  <dc:description/>
  <dc:language>en-US</dc:language>
  <cp:lastModifiedBy>Daniel</cp:lastModifiedBy>
  <dcterms:modified xsi:type="dcterms:W3CDTF">2014-07-08T18:49:05Z</dcterms:modified>
  <cp:revision>89</cp:revision>
  <dc:subject/>
  <dc:title>Slide 1</dc:title>
</cp:coreProperties>
</file>